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2AA4D04-AEFA-4B8D-83C2-36C1708733D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11C7227-A184-4833-95D5-0D4747FC84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74705BE-731C-4507-8F99-999D6484686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8CCC070-4A95-462A-A110-3BFB20DFD28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8795956-2B83-4593-85B1-E7FCAFE3D0F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EC044D9-712B-4BF6-A77B-B73918E62A1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841CCD-2486-4CBB-9849-61B115489E4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D5EDD5D-823F-4B67-A89D-7A4FFB427D7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DFE8DCE-A5A3-4E87-8786-5DAE7D49110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A85E7C-BEE1-40C8-A12B-1AA278CA5FA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F5288DF-9F01-4CB4-B968-C9414CCC09B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83F695A-CAE9-4648-94F0-EE33C3F9CCB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3AD961D-922B-4D31-B640-542AA3B3C1ED}" type="slidenum">
              <a:rPr b="0" lang="es-E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upo 5"/>
          <p:cNvGrpSpPr/>
          <p:nvPr/>
        </p:nvGrpSpPr>
        <p:grpSpPr>
          <a:xfrm>
            <a:off x="1536840" y="3166920"/>
            <a:ext cx="4195800" cy="1800360"/>
            <a:chOff x="1536840" y="3166920"/>
            <a:chExt cx="4195800" cy="1800360"/>
          </a:xfrm>
        </p:grpSpPr>
        <p:graphicFrame>
          <p:nvGraphicFramePr>
            <p:cNvPr id="42" name="Object 6"/>
            <p:cNvGraphicFramePr/>
            <p:nvPr/>
          </p:nvGraphicFramePr>
          <p:xfrm>
            <a:off x="1536840" y="3208320"/>
            <a:ext cx="4055760" cy="1673280"/>
          </p:xfrm>
          <a:graphic>
            <a:graphicData uri="http://schemas.openxmlformats.org/presentationml/2006/ole">
              <p:oleObj r:id="rId1" spid="">
                <p:embed/>
                <p:pic>
                  <p:nvPicPr>
                    <p:cNvPr id="43" name="Object 6" descr=""/>
                    <p:cNvPicPr/>
                    <p:nvPr/>
                  </p:nvPicPr>
                  <p:blipFill>
                    <a:blip r:embed="rId2"/>
                    <a:stretch/>
                  </p:blipFill>
                  <p:spPr>
                    <a:xfrm>
                      <a:off x="1536840" y="3208320"/>
                      <a:ext cx="4055760" cy="1673280"/>
                    </a:xfrm>
                    <a:prstGeom prst="rect">
                      <a:avLst/>
                    </a:prstGeom>
                    <a:ln w="0">
                      <a:noFill/>
                    </a:ln>
                  </p:spPr>
                </p:pic>
              </p:oleObj>
            </a:graphicData>
          </a:graphic>
        </p:graphicFrame>
        <p:sp>
          <p:nvSpPr>
            <p:cNvPr id="44" name="Text Box 10"/>
            <p:cNvSpPr/>
            <p:nvPr/>
          </p:nvSpPr>
          <p:spPr>
            <a:xfrm>
              <a:off x="1836360" y="3273480"/>
              <a:ext cx="1989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                 +               -</a:t>
              </a:r>
              <a:endParaRPr b="0" lang="en-US" sz="1000" spc="-1" strike="noStrike">
                <a:solidFill>
                  <a:srgbClr val="000000"/>
                </a:solidFill>
                <a:latin typeface="Arial"/>
              </a:endParaRPr>
            </a:p>
          </p:txBody>
        </p:sp>
        <p:sp>
          <p:nvSpPr>
            <p:cNvPr id="45" name="Text Box 11"/>
            <p:cNvSpPr/>
            <p:nvPr/>
          </p:nvSpPr>
          <p:spPr>
            <a:xfrm>
              <a:off x="1839960" y="4034880"/>
              <a:ext cx="20246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                 +                -</a:t>
              </a:r>
              <a:endParaRPr b="0" lang="en-US" sz="1000" spc="-1" strike="noStrike">
                <a:solidFill>
                  <a:srgbClr val="000000"/>
                </a:solidFill>
                <a:latin typeface="Arial"/>
              </a:endParaRPr>
            </a:p>
          </p:txBody>
        </p:sp>
        <p:sp>
          <p:nvSpPr>
            <p:cNvPr id="46" name="Rectángulo 4"/>
            <p:cNvSpPr/>
            <p:nvPr/>
          </p:nvSpPr>
          <p:spPr>
            <a:xfrm>
              <a:off x="4221360" y="3166920"/>
              <a:ext cx="1511280" cy="18003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47" name="6 CuadroTexto"/>
          <p:cNvSpPr/>
          <p:nvPr/>
        </p:nvSpPr>
        <p:spPr>
          <a:xfrm>
            <a:off x="236520" y="577800"/>
            <a:ext cx="1652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Times New Roman"/>
                <a:ea typeface="Times New Roman"/>
              </a:rPr>
              <a:t>Supplementary Figure 2</a:t>
            </a:r>
            <a:endParaRPr b="0" lang="en-US" sz="1200" spc="-1" strike="noStrike">
              <a:solidFill>
                <a:srgbClr val="000000"/>
              </a:solidFill>
              <a:latin typeface="Arial"/>
            </a:endParaRPr>
          </a:p>
        </p:txBody>
      </p:sp>
      <p:sp>
        <p:nvSpPr>
          <p:cNvPr id="48" name="Rectangle 8"/>
          <p:cNvSpPr/>
          <p:nvPr/>
        </p:nvSpPr>
        <p:spPr>
          <a:xfrm>
            <a:off x="1138320" y="5754600"/>
            <a:ext cx="3609720" cy="19191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Calibri"/>
              </a:rPr>
              <a:t>Supplemental Figure S2. Hormone treatments induced different effects on sprouting in saffron corms. Signal + refers to the removal of the apical bud. Signal – refers to intact corms with their apical bud. GA3, gibberellic acid; NAA, 1-naphthalene acetic acid; BAP, benzylaminopurine. Surface sterilize corms were grew in MS medium containing or not different hormones at 100 µM final concentration. Picture was taken 10 days after treatment.The table shows the average length of the sprouted axyllary buds.</a:t>
            </a:r>
            <a:endParaRPr b="0" lang="en-US" sz="1200" spc="-1" strike="noStrike">
              <a:solidFill>
                <a:srgbClr val="000000"/>
              </a:solidFill>
              <a:latin typeface="Arial"/>
            </a:endParaRPr>
          </a:p>
        </p:txBody>
      </p:sp>
      <p:sp>
        <p:nvSpPr>
          <p:cNvPr id="49" name="CuadroTexto 8"/>
          <p:cNvSpPr/>
          <p:nvPr/>
        </p:nvSpPr>
        <p:spPr>
          <a:xfrm>
            <a:off x="1967040" y="3844800"/>
            <a:ext cx="19058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Arial"/>
              </a:rPr>
              <a:t>Unteated                    GA3 treated</a:t>
            </a:r>
            <a:endParaRPr b="0" lang="en-US" sz="900" spc="-1" strike="noStrike">
              <a:solidFill>
                <a:srgbClr val="000000"/>
              </a:solidFill>
              <a:latin typeface="Arial"/>
            </a:endParaRPr>
          </a:p>
        </p:txBody>
      </p:sp>
      <p:sp>
        <p:nvSpPr>
          <p:cNvPr id="50" name="CuadroTexto 9"/>
          <p:cNvSpPr/>
          <p:nvPr/>
        </p:nvSpPr>
        <p:spPr>
          <a:xfrm>
            <a:off x="1884240" y="4592520"/>
            <a:ext cx="20325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Arial"/>
              </a:rPr>
              <a:t>NAA treated                  BAP  treated</a:t>
            </a:r>
            <a:endParaRPr b="0" lang="en-US" sz="900" spc="-1" strike="noStrike">
              <a:solidFill>
                <a:srgbClr val="000000"/>
              </a:solidFill>
              <a:latin typeface="Arial"/>
            </a:endParaRPr>
          </a:p>
        </p:txBody>
      </p:sp>
      <p:graphicFrame>
        <p:nvGraphicFramePr>
          <p:cNvPr id="51" name=""/>
          <p:cNvGraphicFramePr/>
          <p:nvPr/>
        </p:nvGraphicFramePr>
        <p:xfrm>
          <a:off x="1515960" y="4967280"/>
          <a:ext cx="2992680" cy="706320"/>
        </p:xfrm>
        <a:graphic>
          <a:graphicData uri="http://schemas.openxmlformats.org/drawingml/2006/table">
            <a:tbl>
              <a:tblPr/>
              <a:tblGrid>
                <a:gridCol w="351000"/>
                <a:gridCol w="690480"/>
                <a:gridCol w="690480"/>
                <a:gridCol w="547920"/>
                <a:gridCol w="712800"/>
              </a:tblGrid>
              <a:tr h="23112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Untreated</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GA3</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NAA</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BAP</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23112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0</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0</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0</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0</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24408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1.17±0.87</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2.31±0.98</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0</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Times New Roman"/>
                          <a:ea typeface="Times New Roman"/>
                        </a:rPr>
                        <a:t>4.82±1.39</a:t>
                      </a:r>
                      <a:endParaRPr b="0" lang="en-US" sz="9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3-12T10:44:04Z</dcterms:created>
  <dc:creator>MariaLourdes.Gomez</dc:creator>
  <dc:description/>
  <dc:language>en-US</dc:language>
  <cp:lastModifiedBy>marialourdes</cp:lastModifiedBy>
  <dcterms:modified xsi:type="dcterms:W3CDTF">2014-06-06T14:35:32Z</dcterms:modified>
  <cp:revision>11</cp:revision>
  <dc:subject/>
  <dc:title>Diapositiva 1</dc:title>
</cp:coreProperties>
</file>